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57" r:id="rId3"/>
    <p:sldId id="258" r:id="rId4"/>
    <p:sldId id="259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EE3B9A5-92BE-444A-AA11-8F8C27E692A1}" v="3" dt="2022-12-19T19:00:53.38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058"/>
    <p:restoredTop sz="94719"/>
  </p:normalViewPr>
  <p:slideViewPr>
    <p:cSldViewPr snapToGrid="0" snapToObjects="1">
      <p:cViewPr>
        <p:scale>
          <a:sx n="100" d="100"/>
          <a:sy n="100" d="100"/>
        </p:scale>
        <p:origin x="4576" y="1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cNulty, Helene" userId="fad3fbee-508c-435c-94fc-ad8d9ca7aee1" providerId="ADAL" clId="{5C034C3D-4926-4D5E-9DB3-2402657C3793}"/>
    <pc:docChg chg="modSld">
      <pc:chgData name="McNulty, Helene" userId="fad3fbee-508c-435c-94fc-ad8d9ca7aee1" providerId="ADAL" clId="{5C034C3D-4926-4D5E-9DB3-2402657C3793}" dt="2022-10-19T09:01:11.989" v="9" actId="14100"/>
      <pc:docMkLst>
        <pc:docMk/>
      </pc:docMkLst>
      <pc:sldChg chg="modSp mod">
        <pc:chgData name="McNulty, Helene" userId="fad3fbee-508c-435c-94fc-ad8d9ca7aee1" providerId="ADAL" clId="{5C034C3D-4926-4D5E-9DB3-2402657C3793}" dt="2022-10-19T09:01:11.989" v="9" actId="14100"/>
        <pc:sldMkLst>
          <pc:docMk/>
          <pc:sldMk cId="3671662889" sldId="256"/>
        </pc:sldMkLst>
        <pc:spChg chg="mod">
          <ac:chgData name="McNulty, Helene" userId="fad3fbee-508c-435c-94fc-ad8d9ca7aee1" providerId="ADAL" clId="{5C034C3D-4926-4D5E-9DB3-2402657C3793}" dt="2022-10-19T09:00:48.229" v="8" actId="14100"/>
          <ac:spMkLst>
            <pc:docMk/>
            <pc:sldMk cId="3671662889" sldId="256"/>
            <ac:spMk id="5" creationId="{A74E017B-FF38-AFC7-6133-554FA7433689}"/>
          </ac:spMkLst>
        </pc:spChg>
        <pc:spChg chg="mod">
          <ac:chgData name="McNulty, Helene" userId="fad3fbee-508c-435c-94fc-ad8d9ca7aee1" providerId="ADAL" clId="{5C034C3D-4926-4D5E-9DB3-2402657C3793}" dt="2022-10-19T09:00:34.229" v="6" actId="14100"/>
          <ac:spMkLst>
            <pc:docMk/>
            <pc:sldMk cId="3671662889" sldId="256"/>
            <ac:spMk id="6" creationId="{1EB25EA0-A0B8-CDE2-210E-A0D82F500E7D}"/>
          </ac:spMkLst>
        </pc:spChg>
        <pc:spChg chg="mod">
          <ac:chgData name="McNulty, Helene" userId="fad3fbee-508c-435c-94fc-ad8d9ca7aee1" providerId="ADAL" clId="{5C034C3D-4926-4D5E-9DB3-2402657C3793}" dt="2022-10-19T08:59:56.749" v="1" actId="20577"/>
          <ac:spMkLst>
            <pc:docMk/>
            <pc:sldMk cId="3671662889" sldId="256"/>
            <ac:spMk id="16" creationId="{81E49ACE-783E-9753-FB01-E073EA29539F}"/>
          </ac:spMkLst>
        </pc:spChg>
        <pc:grpChg chg="mod">
          <ac:chgData name="McNulty, Helene" userId="fad3fbee-508c-435c-94fc-ad8d9ca7aee1" providerId="ADAL" clId="{5C034C3D-4926-4D5E-9DB3-2402657C3793}" dt="2022-10-19T09:01:11.989" v="9" actId="14100"/>
          <ac:grpSpMkLst>
            <pc:docMk/>
            <pc:sldMk cId="3671662889" sldId="256"/>
            <ac:grpSpMk id="4" creationId="{35DB959A-CB03-4A2D-C265-DB796D40FDA5}"/>
          </ac:grpSpMkLst>
        </pc:grpChg>
      </pc:sldChg>
    </pc:docChg>
  </pc:docChgLst>
  <pc:docChgLst>
    <pc:chgData name="Caffrey, Aoife" userId="6289451e-9c44-4f69-aa24-d6e41611f7d3" providerId="ADAL" clId="{FEE3B9A5-92BE-444A-AA11-8F8C27E692A1}"/>
    <pc:docChg chg="modSld">
      <pc:chgData name="Caffrey, Aoife" userId="6289451e-9c44-4f69-aa24-d6e41611f7d3" providerId="ADAL" clId="{FEE3B9A5-92BE-444A-AA11-8F8C27E692A1}" dt="2022-12-19T19:01:45.301" v="142" actId="20577"/>
      <pc:docMkLst>
        <pc:docMk/>
      </pc:docMkLst>
      <pc:sldChg chg="addSp modSp mod">
        <pc:chgData name="Caffrey, Aoife" userId="6289451e-9c44-4f69-aa24-d6e41611f7d3" providerId="ADAL" clId="{FEE3B9A5-92BE-444A-AA11-8F8C27E692A1}" dt="2022-12-19T19:01:45.301" v="142" actId="20577"/>
        <pc:sldMkLst>
          <pc:docMk/>
          <pc:sldMk cId="3671662889" sldId="256"/>
        </pc:sldMkLst>
        <pc:spChg chg="mod">
          <ac:chgData name="Caffrey, Aoife" userId="6289451e-9c44-4f69-aa24-d6e41611f7d3" providerId="ADAL" clId="{FEE3B9A5-92BE-444A-AA11-8F8C27E692A1}" dt="2022-12-19T19:01:04.341" v="111" actId="20577"/>
          <ac:spMkLst>
            <pc:docMk/>
            <pc:sldMk cId="3671662889" sldId="256"/>
            <ac:spMk id="25" creationId="{2857AB0B-4F25-4899-3858-DA72898D58CD}"/>
          </ac:spMkLst>
        </pc:spChg>
        <pc:spChg chg="add mod">
          <ac:chgData name="Caffrey, Aoife" userId="6289451e-9c44-4f69-aa24-d6e41611f7d3" providerId="ADAL" clId="{FEE3B9A5-92BE-444A-AA11-8F8C27E692A1}" dt="2022-12-19T19:01:45.301" v="142" actId="20577"/>
          <ac:spMkLst>
            <pc:docMk/>
            <pc:sldMk cId="3671662889" sldId="256"/>
            <ac:spMk id="31" creationId="{AFF4A74B-F82B-39CE-E034-5817871D3EE5}"/>
          </ac:spMkLst>
        </pc:spChg>
        <pc:cxnChg chg="add mod ord">
          <ac:chgData name="Caffrey, Aoife" userId="6289451e-9c44-4f69-aa24-d6e41611f7d3" providerId="ADAL" clId="{FEE3B9A5-92BE-444A-AA11-8F8C27E692A1}" dt="2022-12-19T18:59:45.461" v="3" actId="14100"/>
          <ac:cxnSpMkLst>
            <pc:docMk/>
            <pc:sldMk cId="3671662889" sldId="256"/>
            <ac:cxnSpMk id="3" creationId="{1979995B-F285-34E5-4949-992426C487B1}"/>
          </ac:cxnSpMkLst>
        </pc:cxnChg>
        <pc:cxnChg chg="add mod">
          <ac:chgData name="Caffrey, Aoife" userId="6289451e-9c44-4f69-aa24-d6e41611f7d3" providerId="ADAL" clId="{FEE3B9A5-92BE-444A-AA11-8F8C27E692A1}" dt="2022-12-19T19:00:00.295" v="49" actId="1036"/>
          <ac:cxnSpMkLst>
            <pc:docMk/>
            <pc:sldMk cId="3671662889" sldId="256"/>
            <ac:cxnSpMk id="27" creationId="{B141A9BA-1C85-CCC3-425A-76B7FAC20669}"/>
          </ac:cxnSpMkLst>
        </pc:cxnChg>
        <pc:cxnChg chg="add mod">
          <ac:chgData name="Caffrey, Aoife" userId="6289451e-9c44-4f69-aa24-d6e41611f7d3" providerId="ADAL" clId="{FEE3B9A5-92BE-444A-AA11-8F8C27E692A1}" dt="2022-12-19T19:01:07.606" v="113" actId="1038"/>
          <ac:cxnSpMkLst>
            <pc:docMk/>
            <pc:sldMk cId="3671662889" sldId="256"/>
            <ac:cxnSpMk id="32" creationId="{D347A41B-E27C-070F-969A-05BE5830F7F8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54C60-A750-1D47-9D74-6F40D921BE65}" type="datetimeFigureOut">
              <a:rPr lang="it-IT" smtClean="0"/>
              <a:t>18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56350-3539-014B-BBC3-0C2871ED35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648208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54C60-A750-1D47-9D74-6F40D921BE65}" type="datetimeFigureOut">
              <a:rPr lang="it-IT" smtClean="0"/>
              <a:t>18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56350-3539-014B-BBC3-0C2871ED35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325351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54C60-A750-1D47-9D74-6F40D921BE65}" type="datetimeFigureOut">
              <a:rPr lang="it-IT" smtClean="0"/>
              <a:t>18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56350-3539-014B-BBC3-0C2871ED35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226775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54C60-A750-1D47-9D74-6F40D921BE65}" type="datetimeFigureOut">
              <a:rPr lang="it-IT" smtClean="0"/>
              <a:t>18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56350-3539-014B-BBC3-0C2871ED35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211773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54C60-A750-1D47-9D74-6F40D921BE65}" type="datetimeFigureOut">
              <a:rPr lang="it-IT" smtClean="0"/>
              <a:t>18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56350-3539-014B-BBC3-0C2871ED35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6896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54C60-A750-1D47-9D74-6F40D921BE65}" type="datetimeFigureOut">
              <a:rPr lang="it-IT" smtClean="0"/>
              <a:t>18/04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56350-3539-014B-BBC3-0C2871ED35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862974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54C60-A750-1D47-9D74-6F40D921BE65}" type="datetimeFigureOut">
              <a:rPr lang="it-IT" smtClean="0"/>
              <a:t>18/04/23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56350-3539-014B-BBC3-0C2871ED35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15640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54C60-A750-1D47-9D74-6F40D921BE65}" type="datetimeFigureOut">
              <a:rPr lang="it-IT" smtClean="0"/>
              <a:t>18/04/23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56350-3539-014B-BBC3-0C2871ED35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435348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54C60-A750-1D47-9D74-6F40D921BE65}" type="datetimeFigureOut">
              <a:rPr lang="it-IT" smtClean="0"/>
              <a:t>18/04/23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56350-3539-014B-BBC3-0C2871ED35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139759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54C60-A750-1D47-9D74-6F40D921BE65}" type="datetimeFigureOut">
              <a:rPr lang="it-IT" smtClean="0"/>
              <a:t>18/04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56350-3539-014B-BBC3-0C2871ED35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22711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54C60-A750-1D47-9D74-6F40D921BE65}" type="datetimeFigureOut">
              <a:rPr lang="it-IT" smtClean="0"/>
              <a:t>18/04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56350-3539-014B-BBC3-0C2871ED35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147865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354C60-A750-1D47-9D74-6F40D921BE65}" type="datetimeFigureOut">
              <a:rPr lang="it-IT" smtClean="0"/>
              <a:t>18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A56350-3539-014B-BBC3-0C2871ED35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955080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1979995B-F285-34E5-4949-992426C487B1}"/>
              </a:ext>
            </a:extLst>
          </p:cNvPr>
          <p:cNvCxnSpPr>
            <a:stCxn id="21" idx="1"/>
          </p:cNvCxnSpPr>
          <p:nvPr/>
        </p:nvCxnSpPr>
        <p:spPr>
          <a:xfrm>
            <a:off x="3565589" y="4189802"/>
            <a:ext cx="0" cy="312539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4" name="Group 56">
            <a:extLst>
              <a:ext uri="{FF2B5EF4-FFF2-40B4-BE49-F238E27FC236}">
                <a16:creationId xmlns:a16="http://schemas.microsoft.com/office/drawing/2014/main" id="{35DB959A-CB03-4A2D-C265-DB796D40FDA5}"/>
              </a:ext>
            </a:extLst>
          </p:cNvPr>
          <p:cNvGrpSpPr/>
          <p:nvPr/>
        </p:nvGrpSpPr>
        <p:grpSpPr>
          <a:xfrm>
            <a:off x="1144367" y="2456139"/>
            <a:ext cx="5445276" cy="6771005"/>
            <a:chOff x="0" y="0"/>
            <a:chExt cx="5675587" cy="6771161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BB5EC72A-0AA3-13F5-C601-D587132E0371}"/>
                </a:ext>
              </a:extLst>
            </p:cNvPr>
            <p:cNvGrpSpPr/>
            <p:nvPr/>
          </p:nvGrpSpPr>
          <p:grpSpPr>
            <a:xfrm>
              <a:off x="0" y="0"/>
              <a:ext cx="5675587" cy="6255186"/>
              <a:chOff x="0" y="0"/>
              <a:chExt cx="5676256" cy="6255544"/>
            </a:xfrm>
          </p:grpSpPr>
          <p:grpSp>
            <p:nvGrpSpPr>
              <p:cNvPr id="9" name="Group 12">
                <a:extLst>
                  <a:ext uri="{FF2B5EF4-FFF2-40B4-BE49-F238E27FC236}">
                    <a16:creationId xmlns:a16="http://schemas.microsoft.com/office/drawing/2014/main" id="{DC4CDDB5-52BE-81F1-4C97-69B0482BD1B3}"/>
                  </a:ext>
                </a:extLst>
              </p:cNvPr>
              <p:cNvGrpSpPr/>
              <p:nvPr/>
            </p:nvGrpSpPr>
            <p:grpSpPr>
              <a:xfrm>
                <a:off x="0" y="0"/>
                <a:ext cx="5676256" cy="5056663"/>
                <a:chOff x="0" y="0"/>
                <a:chExt cx="5677006" cy="5057398"/>
              </a:xfrm>
            </p:grpSpPr>
            <p:grpSp>
              <p:nvGrpSpPr>
                <p:cNvPr id="11" name="Group 13">
                  <a:extLst>
                    <a:ext uri="{FF2B5EF4-FFF2-40B4-BE49-F238E27FC236}">
                      <a16:creationId xmlns:a16="http://schemas.microsoft.com/office/drawing/2014/main" id="{FD8DC5B3-1BAE-9F06-1ABA-3FB54DA48B8E}"/>
                    </a:ext>
                  </a:extLst>
                </p:cNvPr>
                <p:cNvGrpSpPr/>
                <p:nvPr/>
              </p:nvGrpSpPr>
              <p:grpSpPr>
                <a:xfrm>
                  <a:off x="1296116" y="3902840"/>
                  <a:ext cx="4367266" cy="1154558"/>
                  <a:chOff x="220890" y="714305"/>
                  <a:chExt cx="4368113" cy="1154793"/>
                </a:xfrm>
              </p:grpSpPr>
              <p:sp>
                <p:nvSpPr>
                  <p:cNvPr id="25" name="Rectangle: Rounded Corners 14">
                    <a:extLst>
                      <a:ext uri="{FF2B5EF4-FFF2-40B4-BE49-F238E27FC236}">
                        <a16:creationId xmlns:a16="http://schemas.microsoft.com/office/drawing/2014/main" id="{2857AB0B-4F25-4899-3858-DA72898D58CD}"/>
                      </a:ext>
                    </a:extLst>
                  </p:cNvPr>
                  <p:cNvSpPr/>
                  <p:nvPr/>
                </p:nvSpPr>
                <p:spPr>
                  <a:xfrm>
                    <a:off x="220890" y="1352926"/>
                    <a:ext cx="2502002" cy="516172"/>
                  </a:xfrm>
                  <a:prstGeom prst="roundRect">
                    <a:avLst/>
                  </a:prstGeom>
                  <a:solidFill>
                    <a:sysClr val="window" lastClr="FFFFFF"/>
                  </a:solidFill>
                  <a:ln w="1270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ot="0" spcFirstLastPara="0" vert="horz" wrap="square" lIns="91440" tIns="45720" rIns="91440" bIns="4572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>
                      <a:lnSpc>
                        <a:spcPct val="107000"/>
                      </a:lnSpc>
                      <a:spcAft>
                        <a:spcPts val="800"/>
                      </a:spcAft>
                    </a:pPr>
                    <a:r>
                      <a:rPr lang="en-GB" sz="12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Available blood sample</a:t>
                    </a:r>
                    <a:br>
                      <a: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</a:br>
                    <a:r>
                      <a: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(n=875)</a:t>
                    </a:r>
                    <a:endParaRPr lang="it-IT" sz="1200" dirty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Calibri" panose="020F0502020204030204" pitchFamily="34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6" name="Rectangle: Rounded Corners 19">
                    <a:extLst>
                      <a:ext uri="{FF2B5EF4-FFF2-40B4-BE49-F238E27FC236}">
                        <a16:creationId xmlns:a16="http://schemas.microsoft.com/office/drawing/2014/main" id="{57E840ED-B906-2218-AF25-E7FE670DD760}"/>
                      </a:ext>
                    </a:extLst>
                  </p:cNvPr>
                  <p:cNvSpPr/>
                  <p:nvPr/>
                </p:nvSpPr>
                <p:spPr>
                  <a:xfrm>
                    <a:off x="1616518" y="714305"/>
                    <a:ext cx="2972485" cy="492631"/>
                  </a:xfrm>
                  <a:prstGeom prst="roundRect">
                    <a:avLst/>
                  </a:prstGeom>
                  <a:solidFill>
                    <a:sysClr val="window" lastClr="FFFFFF"/>
                  </a:solidFill>
                  <a:ln w="1270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ot="0" spcFirstLastPara="0" vert="horz" wrap="square" lIns="91440" tIns="45720" rIns="91440" bIns="4572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>
                      <a:lnSpc>
                        <a:spcPct val="107000"/>
                      </a:lnSpc>
                      <a:spcAft>
                        <a:spcPts val="800"/>
                      </a:spcAft>
                    </a:pPr>
                    <a:r>
                      <a:rPr lang="en-GB" sz="1200" b="1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Excluded (n=78)</a:t>
                    </a:r>
                    <a:br>
                      <a: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</a:br>
                    <a:r>
                      <a:rPr lang="en-GB" sz="11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- Missing blood sample (n=78)</a:t>
                    </a:r>
                    <a:endParaRPr lang="it-IT" sz="120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Calibri" panose="020F0502020204030204" pitchFamily="34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2" name="Group 21">
                  <a:extLst>
                    <a:ext uri="{FF2B5EF4-FFF2-40B4-BE49-F238E27FC236}">
                      <a16:creationId xmlns:a16="http://schemas.microsoft.com/office/drawing/2014/main" id="{A5647008-145C-9127-46D9-0B0AB0BD56AE}"/>
                    </a:ext>
                  </a:extLst>
                </p:cNvPr>
                <p:cNvGrpSpPr/>
                <p:nvPr/>
              </p:nvGrpSpPr>
              <p:grpSpPr>
                <a:xfrm>
                  <a:off x="0" y="0"/>
                  <a:ext cx="5677006" cy="3786033"/>
                  <a:chOff x="0" y="0"/>
                  <a:chExt cx="5494680" cy="3425673"/>
                </a:xfrm>
              </p:grpSpPr>
              <p:grpSp>
                <p:nvGrpSpPr>
                  <p:cNvPr id="13" name="Group 26">
                    <a:extLst>
                      <a:ext uri="{FF2B5EF4-FFF2-40B4-BE49-F238E27FC236}">
                        <a16:creationId xmlns:a16="http://schemas.microsoft.com/office/drawing/2014/main" id="{26752439-AB7C-7067-D1BD-70456C48F5C5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0"/>
                    <a:ext cx="3654054" cy="1569004"/>
                    <a:chOff x="0" y="0"/>
                    <a:chExt cx="3654054" cy="1569004"/>
                  </a:xfrm>
                </p:grpSpPr>
                <p:sp>
                  <p:nvSpPr>
                    <p:cNvPr id="17" name="Rectangle: Rounded Corners 27">
                      <a:extLst>
                        <a:ext uri="{FF2B5EF4-FFF2-40B4-BE49-F238E27FC236}">
                          <a16:creationId xmlns:a16="http://schemas.microsoft.com/office/drawing/2014/main" id="{9C40F86D-C8F5-44E7-F181-BF15C2E2F0D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3648" y="818866"/>
                      <a:ext cx="1183809" cy="706133"/>
                    </a:xfrm>
                    <a:prstGeom prst="roundRect">
                      <a:avLst/>
                    </a:prstGeom>
                    <a:noFill/>
                    <a:ln w="1270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ot="0" spcFirstLastPara="0" vert="horz" wrap="square" lIns="91440" tIns="45720" rIns="91440" bIns="45720" numCol="1" spcCol="0" rtlCol="0" fromWordArt="0" anchor="ctr" anchorCtr="0" forceAA="0" compatLnSpc="1">
                      <a:prstTxWarp prst="textNoShape">
                        <a:avLst/>
                      </a:prstTxWarp>
                      <a:noAutofit/>
                    </a:bodyPr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gnitive</a:t>
                      </a:r>
                      <a:b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</a:b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ub-cohort</a:t>
                      </a:r>
                      <a:b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</a:b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n=1,699)</a:t>
                      </a:r>
                      <a:endParaRPr lang="it-IT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8" name="Rectangle: Rounded Corners 29">
                      <a:extLst>
                        <a:ext uri="{FF2B5EF4-FFF2-40B4-BE49-F238E27FC236}">
                          <a16:creationId xmlns:a16="http://schemas.microsoft.com/office/drawing/2014/main" id="{7F00B520-2909-E5C4-FA04-15E5DB4C856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470245" y="812042"/>
                      <a:ext cx="1183809" cy="706133"/>
                    </a:xfrm>
                    <a:prstGeom prst="roundRect">
                      <a:avLst/>
                    </a:prstGeom>
                    <a:noFill/>
                    <a:ln w="1270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ot="0" spcFirstLastPara="0" vert="horz" wrap="square" lIns="91440" tIns="45720" rIns="91440" bIns="45720" numCol="1" spcCol="0" rtlCol="0" fromWordArt="0" anchor="ctr" anchorCtr="0" forceAA="0" compatLnSpc="1">
                      <a:prstTxWarp prst="textNoShape">
                        <a:avLst/>
                      </a:prstTxWarp>
                      <a:noAutofit/>
                    </a:bodyPr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one</a:t>
                      </a:r>
                      <a:b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</a:b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ub-cohort</a:t>
                      </a:r>
                      <a:b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</a:b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n=1,394)</a:t>
                      </a:r>
                      <a:endParaRPr lang="it-IT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p:txBody>
                </p:sp>
                <p:grpSp>
                  <p:nvGrpSpPr>
                    <p:cNvPr id="19" name="Group 32">
                      <a:extLst>
                        <a:ext uri="{FF2B5EF4-FFF2-40B4-BE49-F238E27FC236}">
                          <a16:creationId xmlns:a16="http://schemas.microsoft.com/office/drawing/2014/main" id="{E32DED3B-45F5-3911-00C9-0CB2BDE4B38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0"/>
                      <a:ext cx="3641318" cy="818284"/>
                      <a:chOff x="0" y="0"/>
                      <a:chExt cx="3641318" cy="818284"/>
                    </a:xfrm>
                  </p:grpSpPr>
                  <p:sp>
                    <p:nvSpPr>
                      <p:cNvPr id="22" name="Left Bracket 36">
                        <a:extLst>
                          <a:ext uri="{FF2B5EF4-FFF2-40B4-BE49-F238E27FC236}">
                            <a16:creationId xmlns:a16="http://schemas.microsoft.com/office/drawing/2014/main" id="{6800D01E-75D1-89B6-6664-17CD4EEBE3AA}"/>
                          </a:ext>
                        </a:extLst>
                      </p:cNvPr>
                      <p:cNvSpPr/>
                      <p:nvPr/>
                    </p:nvSpPr>
                    <p:spPr>
                      <a:xfrm rot="5400000">
                        <a:off x="1768338" y="-435776"/>
                        <a:ext cx="75000" cy="2433119"/>
                      </a:xfrm>
                      <a:prstGeom prst="leftBracket">
                        <a:avLst/>
                      </a:prstGeom>
                      <a:noFill/>
                      <a:ln w="6350" cap="flat" cmpd="sng" algn="ctr">
                        <a:solidFill>
                          <a:sysClr val="windowText" lastClr="000000"/>
                        </a:solidFill>
                        <a:prstDash val="solid"/>
                        <a:miter lim="800000"/>
                      </a:ln>
                      <a:effectLst/>
                    </p:spPr>
                    <p:txBody>
                      <a:bodyPr rot="0" spcFirstLastPara="0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endParaRPr lang="it-IT"/>
                      </a:p>
                    </p:txBody>
                  </p:sp>
                  <p:sp>
                    <p:nvSpPr>
                      <p:cNvPr id="23" name="Rectangle: Rounded Corners 37">
                        <a:extLst>
                          <a:ext uri="{FF2B5EF4-FFF2-40B4-BE49-F238E27FC236}">
                            <a16:creationId xmlns:a16="http://schemas.microsoft.com/office/drawing/2014/main" id="{E70F7A49-C551-5432-F6BC-09447D8FAB07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0" y="0"/>
                        <a:ext cx="3641318" cy="666680"/>
                      </a:xfrm>
                      <a:prstGeom prst="roundRect">
                        <a:avLst/>
                      </a:prstGeom>
                      <a:noFill/>
                      <a:ln w="12700" cap="flat" cmpd="sng" algn="ctr">
                        <a:solidFill>
                          <a:sysClr val="windowText" lastClr="000000"/>
                        </a:solidFill>
                        <a:prstDash val="solid"/>
                        <a:miter lim="800000"/>
                      </a:ln>
                      <a:effectLst/>
                    </p:spPr>
                    <p:txBody>
                      <a:bodyPr rot="0" spcFirstLastPara="0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>
                          <a:lnSpc>
                            <a:spcPct val="107000"/>
                          </a:lnSpc>
                          <a:spcAft>
                            <a:spcPts val="800"/>
                          </a:spcAft>
                        </a:pPr>
                        <a:r>
                          <a:rPr lang="en-GB" sz="120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  <a:t>Trinity-Ulster-Department of Agriculture </a:t>
                        </a:r>
                        <a:br>
                          <a:rPr lang="en-GB" sz="120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</a:br>
                        <a:r>
                          <a:rPr lang="en-GB" sz="1200" b="1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  <a:t>(TUDA)</a:t>
                        </a:r>
                        <a:r>
                          <a:rPr lang="en-GB" sz="120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  <a:t> Study</a:t>
                        </a:r>
                        <a:br>
                          <a:rPr lang="en-GB" sz="120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</a:br>
                        <a:r>
                          <a:rPr lang="en-GB" sz="120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  <a:t>(n=5,186)</a:t>
                        </a:r>
                        <a:endParaRPr lang="it-IT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cxnSp>
                    <p:nvCxnSpPr>
                      <p:cNvPr id="24" name="Straight Connector 38">
                        <a:extLst>
                          <a:ext uri="{FF2B5EF4-FFF2-40B4-BE49-F238E27FC236}">
                            <a16:creationId xmlns:a16="http://schemas.microsoft.com/office/drawing/2014/main" id="{4C95BB35-570E-33FD-F17D-2EE44EEADB84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842448" y="661917"/>
                        <a:ext cx="0" cy="151130"/>
                      </a:xfrm>
                      <a:prstGeom prst="line">
                        <a:avLst/>
                      </a:prstGeom>
                      <a:noFill/>
                      <a:ln w="6350" cap="flat" cmpd="sng" algn="ctr">
                        <a:solidFill>
                          <a:sysClr val="windowText" lastClr="000000"/>
                        </a:solidFill>
                        <a:prstDash val="solid"/>
                        <a:miter lim="800000"/>
                      </a:ln>
                      <a:effectLst/>
                    </p:spPr>
                  </p:cxnSp>
                </p:grpSp>
                <p:sp>
                  <p:nvSpPr>
                    <p:cNvPr id="20" name="Rectangle: Rounded Corners 39">
                      <a:extLst>
                        <a:ext uri="{FF2B5EF4-FFF2-40B4-BE49-F238E27FC236}">
                          <a16:creationId xmlns:a16="http://schemas.microsoft.com/office/drawing/2014/main" id="{3A0C1E48-89F8-5BDC-5D5B-8E43FA02F09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235122" y="818866"/>
                      <a:ext cx="1183809" cy="706093"/>
                    </a:xfrm>
                    <a:prstGeom prst="roundRect">
                      <a:avLst/>
                    </a:prstGeom>
                    <a:noFill/>
                    <a:ln w="1270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ot="0" spcFirstLastPara="0" vert="horz" wrap="square" lIns="91440" tIns="45720" rIns="91440" bIns="45720" numCol="1" spcCol="0" rtlCol="0" fromWordArt="0" anchor="ctr" anchorCtr="0" forceAA="0" compatLnSpc="1">
                      <a:prstTxWarp prst="textNoShape">
                        <a:avLst/>
                      </a:prstTxWarp>
                      <a:noAutofit/>
                    </a:bodyPr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ypertensive</a:t>
                      </a:r>
                      <a:b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</a:b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ub-cohort</a:t>
                      </a:r>
                      <a:b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</a:b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n=2,093)</a:t>
                      </a:r>
                      <a:endParaRPr lang="it-IT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1" name="Left Bracket 41">
                      <a:extLst>
                        <a:ext uri="{FF2B5EF4-FFF2-40B4-BE49-F238E27FC236}">
                          <a16:creationId xmlns:a16="http://schemas.microsoft.com/office/drawing/2014/main" id="{16C2B194-3EBC-94B2-BE49-2B2EEC50345B}"/>
                        </a:ext>
                      </a:extLst>
                    </p:cNvPr>
                    <p:cNvSpPr/>
                    <p:nvPr/>
                  </p:nvSpPr>
                  <p:spPr>
                    <a:xfrm rot="16200000">
                      <a:off x="2417664" y="920148"/>
                      <a:ext cx="51050" cy="1246662"/>
                    </a:xfrm>
                    <a:prstGeom prst="leftBracket">
                      <a:avLst/>
                    </a:prstGeom>
                    <a:noFill/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ot="0" spcFirstLastPara="0" vert="horz" wrap="square" lIns="91440" tIns="45720" rIns="91440" bIns="45720" numCol="1" spcCol="0" rtlCol="0" fromWordArt="0" anchor="ctr" anchorCtr="0" forceAA="0" compatLnSpc="1">
                      <a:prstTxWarp prst="textNoShape">
                        <a:avLst/>
                      </a:prstTxWarp>
                      <a:noAutofit/>
                    </a:bodyPr>
                    <a:lstStyle/>
                    <a:p>
                      <a:endParaRPr lang="it-IT"/>
                    </a:p>
                  </p:txBody>
                </p:sp>
              </p:grpSp>
              <p:cxnSp>
                <p:nvCxnSpPr>
                  <p:cNvPr id="14" name="Straight Connector 42">
                    <a:extLst>
                      <a:ext uri="{FF2B5EF4-FFF2-40B4-BE49-F238E27FC236}">
                        <a16:creationId xmlns:a16="http://schemas.microsoft.com/office/drawing/2014/main" id="{2BB8E223-2ECF-B4E4-858B-98918E8340C8}"/>
                      </a:ext>
                    </a:extLst>
                  </p:cNvPr>
                  <p:cNvCxnSpPr/>
                  <p:nvPr/>
                </p:nvCxnSpPr>
                <p:spPr>
                  <a:xfrm>
                    <a:off x="2436125" y="2300522"/>
                    <a:ext cx="132776" cy="0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15" name="Rectangle: Rounded Corners 43">
                    <a:extLst>
                      <a:ext uri="{FF2B5EF4-FFF2-40B4-BE49-F238E27FC236}">
                        <a16:creationId xmlns:a16="http://schemas.microsoft.com/office/drawing/2014/main" id="{9FA78691-056B-BC16-5E40-272D63D8EA69}"/>
                      </a:ext>
                    </a:extLst>
                  </p:cNvPr>
                  <p:cNvSpPr/>
                  <p:nvPr/>
                </p:nvSpPr>
                <p:spPr>
                  <a:xfrm>
                    <a:off x="2571835" y="1660820"/>
                    <a:ext cx="2922845" cy="1164047"/>
                  </a:xfrm>
                  <a:prstGeom prst="roundRect">
                    <a:avLst/>
                  </a:prstGeom>
                  <a:noFill/>
                  <a:ln w="1270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ot="0" spcFirstLastPara="0" vert="horz" wrap="square" lIns="91440" tIns="45720" rIns="91440" bIns="4572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>
                      <a:lnSpc>
                        <a:spcPct val="107000"/>
                      </a:lnSpc>
                      <a:spcAft>
                        <a:spcPts val="800"/>
                      </a:spcAft>
                    </a:pPr>
                    <a:r>
                      <a:rPr lang="en-GB" sz="1200" b="1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Ineligible (n=2,534)</a:t>
                    </a:r>
                    <a:br>
                      <a: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</a:br>
                    <a:r>
                      <a:rPr lang="en-GB" sz="11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- &lt; 65 years (n=1,315)</a:t>
                    </a:r>
                    <a:br>
                      <a:rPr lang="en-GB" sz="11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</a:br>
                    <a:r>
                      <a:rPr lang="en-GB" sz="11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- B12 injection users (n=66)</a:t>
                    </a:r>
                    <a:br>
                      <a:rPr lang="en-GB" sz="11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</a:br>
                    <a:r>
                      <a:rPr lang="en-GB" sz="11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- Recorded MMSE &lt;21 (n=39)</a:t>
                    </a:r>
                    <a:br>
                      <a:rPr lang="en-GB" sz="11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</a:br>
                    <a:r>
                      <a:rPr lang="en-GB" sz="11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- Uncontactable, unable or unwilling to further participate (n=1,114)</a:t>
                    </a:r>
                    <a:br>
                      <a: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</a:br>
                    <a:endParaRPr lang="it-IT" sz="120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Calibri" panose="020F0502020204030204" pitchFamily="34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6" name="Rectangle: Rounded Corners 44">
                    <a:extLst>
                      <a:ext uri="{FF2B5EF4-FFF2-40B4-BE49-F238E27FC236}">
                        <a16:creationId xmlns:a16="http://schemas.microsoft.com/office/drawing/2014/main" id="{81E49ACE-783E-9753-FB01-E073EA29539F}"/>
                      </a:ext>
                    </a:extLst>
                  </p:cNvPr>
                  <p:cNvSpPr/>
                  <p:nvPr/>
                </p:nvSpPr>
                <p:spPr>
                  <a:xfrm>
                    <a:off x="1249283" y="2994472"/>
                    <a:ext cx="2418932" cy="431201"/>
                  </a:xfrm>
                  <a:prstGeom prst="roundRect">
                    <a:avLst/>
                  </a:prstGeom>
                  <a:solidFill>
                    <a:sysClr val="window" lastClr="FFFFFF"/>
                  </a:solidFill>
                  <a:ln w="1270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ot="0" spcFirstLastPara="0" vert="horz" wrap="square" lIns="91440" tIns="45720" rIns="91440" bIns="4572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>
                      <a:lnSpc>
                        <a:spcPct val="107000"/>
                      </a:lnSpc>
                      <a:spcAft>
                        <a:spcPts val="800"/>
                      </a:spcAft>
                    </a:pPr>
                    <a:endParaRPr lang="en-GB" sz="1200" b="1" dirty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Calibri" panose="020F0502020204030204" pitchFamily="34" charset="0"/>
                      <a:cs typeface="Times New Roman" panose="02020603050405020304" pitchFamily="18" charset="0"/>
                    </a:endParaRPr>
                  </a:p>
                  <a:p>
                    <a:pPr algn="ctr">
                      <a:lnSpc>
                        <a:spcPct val="107000"/>
                      </a:lnSpc>
                      <a:spcAft>
                        <a:spcPts val="800"/>
                      </a:spcAft>
                    </a:pPr>
                    <a:r>
                      <a:rPr lang="en-GB" sz="12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Potential follow-up sample</a:t>
                    </a:r>
                    <a:br>
                      <a: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</a:br>
                    <a:r>
                      <a: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(n=953)</a:t>
                    </a:r>
                    <a:endParaRPr lang="it-IT" sz="1200" dirty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Calibri" panose="020F0502020204030204" pitchFamily="34" charset="0"/>
                      <a:cs typeface="Times New Roman" panose="02020603050405020304" pitchFamily="18" charset="0"/>
                    </a:endParaRPr>
                  </a:p>
                  <a:p>
                    <a:pPr algn="ctr">
                      <a:lnSpc>
                        <a:spcPct val="107000"/>
                      </a:lnSpc>
                      <a:spcAft>
                        <a:spcPts val="800"/>
                      </a:spcAft>
                    </a:pPr>
                    <a:r>
                      <a: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 </a:t>
                    </a:r>
                    <a:endParaRPr lang="it-IT" sz="1200" dirty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Calibri" panose="020F0502020204030204" pitchFamily="34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cxnSp>
            <p:nvCxnSpPr>
              <p:cNvPr id="10" name="Straight Connector 45">
                <a:extLst>
                  <a:ext uri="{FF2B5EF4-FFF2-40B4-BE49-F238E27FC236}">
                    <a16:creationId xmlns:a16="http://schemas.microsoft.com/office/drawing/2014/main" id="{0BDC6379-4169-5F69-019C-1B62D85A3DF8}"/>
                  </a:ext>
                </a:extLst>
              </p:cNvPr>
              <p:cNvCxnSpPr/>
              <p:nvPr/>
            </p:nvCxnSpPr>
            <p:spPr>
              <a:xfrm>
                <a:off x="2561042" y="5056660"/>
                <a:ext cx="14444" cy="1198884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</p:grpSp>
        <p:sp>
          <p:nvSpPr>
            <p:cNvPr id="8" name="Rectangle: Rounded Corners 55">
              <a:extLst>
                <a:ext uri="{FF2B5EF4-FFF2-40B4-BE49-F238E27FC236}">
                  <a16:creationId xmlns:a16="http://schemas.microsoft.com/office/drawing/2014/main" id="{C5EE91CD-A00A-E8F0-463E-21D685D0F91A}"/>
                </a:ext>
              </a:extLst>
            </p:cNvPr>
            <p:cNvSpPr/>
            <p:nvPr/>
          </p:nvSpPr>
          <p:spPr>
            <a:xfrm>
              <a:off x="1325942" y="6255200"/>
              <a:ext cx="2500632" cy="515961"/>
            </a:xfrm>
            <a:prstGeom prst="roundRect">
              <a:avLst/>
            </a:prstGeom>
            <a:solidFill>
              <a:sysClr val="window" lastClr="FFFF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GB" sz="1200" b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Final follow-up sample</a:t>
              </a:r>
              <a:br>
                <a:rPr lang="en-GB" sz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lang="en-GB" sz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=557)</a:t>
              </a:r>
              <a:endParaRPr lang="it-IT" sz="12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" name="Text Box 2">
            <a:extLst>
              <a:ext uri="{FF2B5EF4-FFF2-40B4-BE49-F238E27FC236}">
                <a16:creationId xmlns:a16="http://schemas.microsoft.com/office/drawing/2014/main" id="{A74E017B-FF38-AFC7-6133-554FA74336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2613619"/>
            <a:ext cx="1257300" cy="4711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1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itial sampling</a:t>
            </a:r>
            <a:r>
              <a:rPr lang="en-GB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br>
              <a:rPr lang="en-GB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11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008 - 2012</a:t>
            </a:r>
            <a:endParaRPr lang="it-IT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Text Box 2">
            <a:extLst>
              <a:ext uri="{FF2B5EF4-FFF2-40B4-BE49-F238E27FC236}">
                <a16:creationId xmlns:a16="http://schemas.microsoft.com/office/drawing/2014/main" id="{1EB25EA0-A0B8-CDE2-210E-A0D82F500E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599" y="6972259"/>
            <a:ext cx="1626747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1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llow-up sampling</a:t>
            </a:r>
            <a:r>
              <a:rPr lang="en-GB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br>
              <a:rPr lang="en-GB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11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014 – 2018</a:t>
            </a:r>
            <a:endParaRPr lang="it-IT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4C74E2F6-9E05-DFCF-3AA6-B6CEA1DC6077}"/>
              </a:ext>
            </a:extLst>
          </p:cNvPr>
          <p:cNvSpPr txBox="1"/>
          <p:nvPr/>
        </p:nvSpPr>
        <p:spPr>
          <a:xfrm>
            <a:off x="300003" y="1088821"/>
            <a:ext cx="6152312" cy="57688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1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ow diagram of study design and eligible participants</a:t>
            </a:r>
            <a:endParaRPr lang="it-IT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breviation: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MSE, mini-mental state examination.</a:t>
            </a:r>
            <a:endParaRPr lang="it-IT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D6B2A397-E809-C7A1-4A5F-432C300A5488}"/>
              </a:ext>
            </a:extLst>
          </p:cNvPr>
          <p:cNvSpPr txBox="1"/>
          <p:nvPr/>
        </p:nvSpPr>
        <p:spPr>
          <a:xfrm>
            <a:off x="268356" y="121813"/>
            <a:ext cx="632128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ociation of </a:t>
            </a:r>
            <a:r>
              <a:rPr lang="it-IT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etary</a:t>
            </a:r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lavan-3-ol </a:t>
            </a:r>
            <a:r>
              <a:rPr lang="it-IT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akes</a:t>
            </a:r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plasma </a:t>
            </a:r>
            <a:r>
              <a:rPr lang="it-IT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enyl</a:t>
            </a:r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l-G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-</a:t>
            </a:r>
            <a:r>
              <a:rPr lang="it-IT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erolactones</a:t>
            </a:r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it-IT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the TUDA </a:t>
            </a:r>
            <a:r>
              <a:rPr lang="it-IT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hort</a:t>
            </a:r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it-IT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lthy</a:t>
            </a:r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lder</a:t>
            </a:r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ults</a:t>
            </a:r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nato Angelino,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oife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ffrey et al.</a:t>
            </a:r>
          </a:p>
        </p:txBody>
      </p:sp>
      <p:cxnSp>
        <p:nvCxnSpPr>
          <p:cNvPr id="27" name="Straight Connector 42">
            <a:extLst>
              <a:ext uri="{FF2B5EF4-FFF2-40B4-BE49-F238E27FC236}">
                <a16:creationId xmlns:a16="http://schemas.microsoft.com/office/drawing/2014/main" id="{B141A9BA-1C85-CCC3-425A-76B7FAC20669}"/>
              </a:ext>
            </a:extLst>
          </p:cNvPr>
          <p:cNvCxnSpPr/>
          <p:nvPr/>
        </p:nvCxnSpPr>
        <p:spPr>
          <a:xfrm>
            <a:off x="3577174" y="6622447"/>
            <a:ext cx="131582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31" name="Rectangle: Rounded Corners 19">
            <a:extLst>
              <a:ext uri="{FF2B5EF4-FFF2-40B4-BE49-F238E27FC236}">
                <a16:creationId xmlns:a16="http://schemas.microsoft.com/office/drawing/2014/main" id="{AFF4A74B-F82B-39CE-E034-5817871D3EE5}"/>
              </a:ext>
            </a:extLst>
          </p:cNvPr>
          <p:cNvSpPr/>
          <p:nvPr/>
        </p:nvSpPr>
        <p:spPr>
          <a:xfrm>
            <a:off x="3739045" y="7855785"/>
            <a:ext cx="2850598" cy="492420"/>
          </a:xfrm>
          <a:prstGeom prst="roundRect">
            <a:avLst/>
          </a:prstGeom>
          <a:solidFill>
            <a:sysClr val="window" lastClr="FFFFFF"/>
          </a:solidFill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cluded (</a:t>
            </a:r>
            <a:r>
              <a:rPr lang="en-GB" sz="12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=</a:t>
            </a:r>
            <a:r>
              <a:rPr lang="en-GB" sz="1200" b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18</a:t>
            </a:r>
            <a:r>
              <a:rPr lang="en-GB" sz="12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br>
              <a:rPr lang="en-GB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GB" sz="1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ssing dietary data </a:t>
            </a:r>
            <a:r>
              <a:rPr lang="en-GB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sz="1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=</a:t>
            </a:r>
            <a:r>
              <a:rPr lang="en-GB" sz="110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18</a:t>
            </a:r>
            <a:r>
              <a:rPr lang="en-GB" sz="1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it-IT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32" name="Straight Connector 42">
            <a:extLst>
              <a:ext uri="{FF2B5EF4-FFF2-40B4-BE49-F238E27FC236}">
                <a16:creationId xmlns:a16="http://schemas.microsoft.com/office/drawing/2014/main" id="{D347A41B-E27C-070F-969A-05BE5830F7F8}"/>
              </a:ext>
            </a:extLst>
          </p:cNvPr>
          <p:cNvCxnSpPr/>
          <p:nvPr/>
        </p:nvCxnSpPr>
        <p:spPr>
          <a:xfrm>
            <a:off x="3606913" y="8112994"/>
            <a:ext cx="131582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</p:spTree>
    <p:extLst>
      <p:ext uri="{BB962C8B-B14F-4D97-AF65-F5344CB8AC3E}">
        <p14:creationId xmlns:p14="http://schemas.microsoft.com/office/powerpoint/2010/main" val="36716628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Box 2">
            <a:extLst>
              <a:ext uri="{FF2B5EF4-FFF2-40B4-BE49-F238E27FC236}">
                <a16:creationId xmlns:a16="http://schemas.microsoft.com/office/drawing/2014/main" id="{21AEC79B-4E0A-9F09-B144-35AE1045E2F6}"/>
              </a:ext>
            </a:extLst>
          </p:cNvPr>
          <p:cNvSpPr txBox="1">
            <a:spLocks noChangeArrowheads="1"/>
          </p:cNvSpPr>
          <p:nvPr/>
        </p:nvSpPr>
        <p:spPr bwMode="auto">
          <a:xfrm rot="10800000" flipV="1">
            <a:off x="5875338" y="64395"/>
            <a:ext cx="982662" cy="29845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it-IT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ded: </a:t>
            </a:r>
            <a:endParaRPr kumimoji="0" lang="en-GB" altLang="it-IT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Text Box 1">
            <a:extLst>
              <a:ext uri="{FF2B5EF4-FFF2-40B4-BE49-F238E27FC236}">
                <a16:creationId xmlns:a16="http://schemas.microsoft.com/office/drawing/2014/main" id="{8BB37538-5D2E-CDE8-3B99-339AEAFF3229}"/>
              </a:ext>
            </a:extLst>
          </p:cNvPr>
          <p:cNvSpPr txBox="1">
            <a:spLocks noChangeArrowheads="1"/>
          </p:cNvSpPr>
          <p:nvPr/>
        </p:nvSpPr>
        <p:spPr bwMode="auto">
          <a:xfrm rot="10800000" flipV="1">
            <a:off x="4592638" y="54870"/>
            <a:ext cx="1252537" cy="30797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it-IT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ll duration: </a:t>
            </a:r>
            <a:endParaRPr kumimoji="0" lang="en-GB" altLang="it-IT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Rectangle 3">
            <a:extLst>
              <a:ext uri="{FF2B5EF4-FFF2-40B4-BE49-F238E27FC236}">
                <a16:creationId xmlns:a16="http://schemas.microsoft.com/office/drawing/2014/main" id="{A1C4A802-423D-115D-B1CC-D6B5CC042B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87638" y="2636838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it-IT"/>
          </a:p>
        </p:txBody>
      </p:sp>
      <p:graphicFrame>
        <p:nvGraphicFramePr>
          <p:cNvPr id="9" name="Tabella 8">
            <a:extLst>
              <a:ext uri="{FF2B5EF4-FFF2-40B4-BE49-F238E27FC236}">
                <a16:creationId xmlns:a16="http://schemas.microsoft.com/office/drawing/2014/main" id="{A4E85E52-8A74-C626-4D4E-DDF850301B88}"/>
              </a:ext>
            </a:extLst>
          </p:cNvPr>
          <p:cNvGraphicFramePr>
            <a:graphicFrameLocks noGrp="1"/>
          </p:cNvGraphicFramePr>
          <p:nvPr/>
        </p:nvGraphicFramePr>
        <p:xfrm>
          <a:off x="0" y="743651"/>
          <a:ext cx="6858000" cy="9162343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064988">
                  <a:extLst>
                    <a:ext uri="{9D8B030D-6E8A-4147-A177-3AD203B41FA5}">
                      <a16:colId xmlns:a16="http://schemas.microsoft.com/office/drawing/2014/main" val="3458432383"/>
                    </a:ext>
                  </a:extLst>
                </a:gridCol>
                <a:gridCol w="1158901">
                  <a:extLst>
                    <a:ext uri="{9D8B030D-6E8A-4147-A177-3AD203B41FA5}">
                      <a16:colId xmlns:a16="http://schemas.microsoft.com/office/drawing/2014/main" val="2745986655"/>
                    </a:ext>
                  </a:extLst>
                </a:gridCol>
                <a:gridCol w="2101864">
                  <a:extLst>
                    <a:ext uri="{9D8B030D-6E8A-4147-A177-3AD203B41FA5}">
                      <a16:colId xmlns:a16="http://schemas.microsoft.com/office/drawing/2014/main" val="1992926712"/>
                    </a:ext>
                  </a:extLst>
                </a:gridCol>
                <a:gridCol w="177023">
                  <a:extLst>
                    <a:ext uri="{9D8B030D-6E8A-4147-A177-3AD203B41FA5}">
                      <a16:colId xmlns:a16="http://schemas.microsoft.com/office/drawing/2014/main" val="2616419137"/>
                    </a:ext>
                  </a:extLst>
                </a:gridCol>
                <a:gridCol w="110254">
                  <a:extLst>
                    <a:ext uri="{9D8B030D-6E8A-4147-A177-3AD203B41FA5}">
                      <a16:colId xmlns:a16="http://schemas.microsoft.com/office/drawing/2014/main" val="437296679"/>
                    </a:ext>
                  </a:extLst>
                </a:gridCol>
                <a:gridCol w="633754">
                  <a:extLst>
                    <a:ext uri="{9D8B030D-6E8A-4147-A177-3AD203B41FA5}">
                      <a16:colId xmlns:a16="http://schemas.microsoft.com/office/drawing/2014/main" val="1438063073"/>
                    </a:ext>
                  </a:extLst>
                </a:gridCol>
                <a:gridCol w="578812">
                  <a:extLst>
                    <a:ext uri="{9D8B030D-6E8A-4147-A177-3AD203B41FA5}">
                      <a16:colId xmlns:a16="http://schemas.microsoft.com/office/drawing/2014/main" val="111549721"/>
                    </a:ext>
                  </a:extLst>
                </a:gridCol>
                <a:gridCol w="452315">
                  <a:extLst>
                    <a:ext uri="{9D8B030D-6E8A-4147-A177-3AD203B41FA5}">
                      <a16:colId xmlns:a16="http://schemas.microsoft.com/office/drawing/2014/main" val="711317525"/>
                    </a:ext>
                  </a:extLst>
                </a:gridCol>
                <a:gridCol w="580089">
                  <a:extLst>
                    <a:ext uri="{9D8B030D-6E8A-4147-A177-3AD203B41FA5}">
                      <a16:colId xmlns:a16="http://schemas.microsoft.com/office/drawing/2014/main" val="1334896249"/>
                    </a:ext>
                  </a:extLst>
                </a:gridCol>
              </a:tblGrid>
              <a:tr h="14119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ID:        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gridSpan="8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                                         FFQ for the VALID project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2205428"/>
                  </a:ext>
                </a:extLst>
              </a:tr>
              <a:tr h="1421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DOB:        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Date: 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Researcher: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gridSpan="5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Average use last year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2165192"/>
                  </a:ext>
                </a:extLst>
              </a:tr>
              <a:tr h="14119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Has your diet changed significantly within the past two years? 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(circle answer)        Yes      Or       No   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0521350"/>
                  </a:ext>
                </a:extLst>
              </a:tr>
              <a:tr h="14119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If Yes how? 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8602547"/>
                  </a:ext>
                </a:extLst>
              </a:tr>
              <a:tr h="533921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1) Do you drink tea or coffee?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Never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Monthly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Weekly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Daily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&gt;1/day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319082249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One cup of black tea or tea with milk 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3873852520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One cup of green tea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186564095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One cup of herbal tea: circle: Camomile or peppermint  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1155512443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One cup of coffee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1055273556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User specified open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363988907"/>
                  </a:ext>
                </a:extLst>
              </a:tr>
              <a:tr h="533921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2) Do you eat cereals?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Never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Monthly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Weekly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Daily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&gt;1/day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1643306386"/>
                  </a:ext>
                </a:extLst>
              </a:tr>
              <a:tr h="142088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A bowl of whole grain oats (cooked) such as porridge or readybrek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1831180726"/>
                  </a:ext>
                </a:extLst>
              </a:tr>
              <a:tr h="142088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A bowl of whole grain wheat such as Weetabix or shredded wheat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1293782713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A bowl of muesli such as Alpen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2880632740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User specified open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3753631767"/>
                  </a:ext>
                </a:extLst>
              </a:tr>
              <a:tr h="533921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3) Do you eat breads or grain products?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Never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Monthly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Weekly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Daily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&gt;1/day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1154931864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Two slices or a roll of wholegrain wheat bread (eg. wheaten bread)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1070739834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Two slices or a roll of wholegrain rye bread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2708688199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Two slices or a roll of white bread 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1271585561"/>
                  </a:ext>
                </a:extLst>
              </a:tr>
              <a:tr h="146878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A serve of white pasta 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390689450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One lunch size whole grain wheat cracker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2563030138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Two tblsp boiled barley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432407432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Whole grain sorghum products – if yes type: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2545100205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User specified open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4072041390"/>
                  </a:ext>
                </a:extLst>
              </a:tr>
              <a:tr h="533921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4) Do you eat fruit?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ctr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Never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Monthly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Weekly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Daily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&gt;1/day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1335165191"/>
                  </a:ext>
                </a:extLst>
              </a:tr>
              <a:tr h="142088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One whole apple 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3465191704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One whole banana 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630014165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One whole plum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406499761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One whole pear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2475836869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One whole peach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1346281588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One whole nectarine 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3531939939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One whole apricot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1500887932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One whole kiwi 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959976797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One whole mango 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1947927405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One bunch of black grapes 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618343376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One bunch of green grapes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2001701972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One bunch of red grapes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23114263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A ½ cup of blackcurrant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3727412768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A ½ cup of blackberry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2945973480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A ½ cup of blueberry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1329302591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A ½ cup of raspberry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3591187665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A ½ cup of strawberry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804062540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A ½ cup of cherries 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1096107871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A ½ cup of pomegranate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1237995679"/>
                  </a:ext>
                </a:extLst>
              </a:tr>
              <a:tr h="142088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User specified open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2721681219"/>
                  </a:ext>
                </a:extLst>
              </a:tr>
              <a:tr h="533921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5) Do you drink fruit juice? (not cordial/diluted or mix up) 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ctr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Never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Monthly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Weekly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Daily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&gt;1/day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1635466054"/>
                  </a:ext>
                </a:extLst>
              </a:tr>
              <a:tr h="157933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A glass of apple juice or cider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900" dirty="0">
                          <a:effectLst/>
                        </a:rPr>
                        <a:t> 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9000" marR="39000" marT="0" marB="0"/>
                </a:tc>
                <a:extLst>
                  <a:ext uri="{0D108BD9-81ED-4DB2-BD59-A6C34878D82A}">
                    <a16:rowId xmlns:a16="http://schemas.microsoft.com/office/drawing/2014/main" val="4159440306"/>
                  </a:ext>
                </a:extLst>
              </a:tr>
            </a:tbl>
          </a:graphicData>
        </a:graphic>
      </p:graphicFrame>
      <p:sp>
        <p:nvSpPr>
          <p:cNvPr id="2" name="CasellaDiTesto 1">
            <a:extLst>
              <a:ext uri="{FF2B5EF4-FFF2-40B4-BE49-F238E27FC236}">
                <a16:creationId xmlns:a16="http://schemas.microsoft.com/office/drawing/2014/main" id="{169006F8-8A32-8DE8-61B7-6C7528C9CB10}"/>
              </a:ext>
            </a:extLst>
          </p:cNvPr>
          <p:cNvSpPr txBox="1"/>
          <p:nvPr/>
        </p:nvSpPr>
        <p:spPr>
          <a:xfrm>
            <a:off x="0" y="54869"/>
            <a:ext cx="45624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Semi-quantitative Food Frequency Questionnaire for the assessment of the habitual (poly)phenol intake in the TUDA cohort. 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05458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a 3">
            <a:extLst>
              <a:ext uri="{FF2B5EF4-FFF2-40B4-BE49-F238E27FC236}">
                <a16:creationId xmlns:a16="http://schemas.microsoft.com/office/drawing/2014/main" id="{85ABAE7D-24BC-1EED-FF8A-57CA323147EE}"/>
              </a:ext>
            </a:extLst>
          </p:cNvPr>
          <p:cNvGraphicFramePr>
            <a:graphicFrameLocks noGrp="1"/>
          </p:cNvGraphicFramePr>
          <p:nvPr/>
        </p:nvGraphicFramePr>
        <p:xfrm>
          <a:off x="0" y="0"/>
          <a:ext cx="6858000" cy="9906020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4199648">
                  <a:extLst>
                    <a:ext uri="{9D8B030D-6E8A-4147-A177-3AD203B41FA5}">
                      <a16:colId xmlns:a16="http://schemas.microsoft.com/office/drawing/2014/main" val="1961140031"/>
                    </a:ext>
                  </a:extLst>
                </a:gridCol>
                <a:gridCol w="478825">
                  <a:extLst>
                    <a:ext uri="{9D8B030D-6E8A-4147-A177-3AD203B41FA5}">
                      <a16:colId xmlns:a16="http://schemas.microsoft.com/office/drawing/2014/main" val="2570767960"/>
                    </a:ext>
                  </a:extLst>
                </a:gridCol>
                <a:gridCol w="615279">
                  <a:extLst>
                    <a:ext uri="{9D8B030D-6E8A-4147-A177-3AD203B41FA5}">
                      <a16:colId xmlns:a16="http://schemas.microsoft.com/office/drawing/2014/main" val="3239213016"/>
                    </a:ext>
                  </a:extLst>
                </a:gridCol>
                <a:gridCol w="561939">
                  <a:extLst>
                    <a:ext uri="{9D8B030D-6E8A-4147-A177-3AD203B41FA5}">
                      <a16:colId xmlns:a16="http://schemas.microsoft.com/office/drawing/2014/main" val="1471425224"/>
                    </a:ext>
                  </a:extLst>
                </a:gridCol>
                <a:gridCol w="439130">
                  <a:extLst>
                    <a:ext uri="{9D8B030D-6E8A-4147-A177-3AD203B41FA5}">
                      <a16:colId xmlns:a16="http://schemas.microsoft.com/office/drawing/2014/main" val="2412184549"/>
                    </a:ext>
                  </a:extLst>
                </a:gridCol>
                <a:gridCol w="563179">
                  <a:extLst>
                    <a:ext uri="{9D8B030D-6E8A-4147-A177-3AD203B41FA5}">
                      <a16:colId xmlns:a16="http://schemas.microsoft.com/office/drawing/2014/main" val="672573909"/>
                    </a:ext>
                  </a:extLst>
                </a:gridCol>
              </a:tblGrid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glass of plum juice or prune juice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3717018653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glass of pomegranate juice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3252143432"/>
                  </a:ext>
                </a:extLst>
              </a:tr>
              <a:tr h="19413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glass of peach juice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4271650322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glass of green grape juice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2348047198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glass of blackcurrant juice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787392793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glass of blackberry juice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2563748354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glass of blueberry juice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3118710208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glass of raspberry juice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3627897878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glass of strawberry juice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902421244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glass of orange juice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848784083"/>
                  </a:ext>
                </a:extLst>
              </a:tr>
              <a:tr h="19413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glass of cranberry juice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13551354"/>
                  </a:ext>
                </a:extLst>
              </a:tr>
              <a:tr h="19413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glass of cherry juice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559494650"/>
                  </a:ext>
                </a:extLst>
              </a:tr>
              <a:tr h="19413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glass of grapefruit juice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3930627575"/>
                  </a:ext>
                </a:extLst>
              </a:tr>
              <a:tr h="19413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Fruit smoothies – if yes type: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2058228451"/>
                  </a:ext>
                </a:extLst>
              </a:tr>
              <a:tr h="19413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User specified open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3751243381"/>
                  </a:ext>
                </a:extLst>
              </a:tr>
              <a:tr h="19413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6) Do you eat jams or marmalades?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Never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Monthly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Weekly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Daily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&gt;1/day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104276300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heaped tspn of apple marmalade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1332978472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heaped tspn of plum jam or marmalade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3333051010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heaped tspn of blackcurrant jam or marmalade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2955157473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heaped tspn of blackberry jam or marmalade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676575371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heaped tspn of blueberry jam or marmalade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1213536745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heaped tspn of raspberry jam or marmalade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716922044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heaped tspn of strawberry jam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4068490790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heaped tspn of apricot jam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2710036917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heaped tspn of orange marmalade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4263980549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User specified open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3320631643"/>
                  </a:ext>
                </a:extLst>
              </a:tr>
              <a:tr h="23555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7) Do you eat chocolate or drink chocolate drinks?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Never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Monthly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Weekly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Daily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&gt;1/day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1694499746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row (4 squares) of plain dark chocolate 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2614332874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row (4 squares) of plain milk chocolate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2476001324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ny additional average size chocolate bars 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3635272596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heaped tspn of cocoa powder for example chocolate milk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2672971313"/>
                  </a:ext>
                </a:extLst>
              </a:tr>
              <a:tr h="19413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Two chocolate containing biscuit – if yes type: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61392763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User specified open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1539614076"/>
                  </a:ext>
                </a:extLst>
              </a:tr>
              <a:tr h="19413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8) Do you eat nuts?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Never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Monthly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Weekly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Daily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&gt;1/day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2745393950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bout a handful of peanuts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2362850434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</a:t>
                      </a:r>
                      <a:r>
                        <a:rPr lang="it-IT" sz="1000">
                          <a:effectLst/>
                        </a:rPr>
                        <a:t>tblsp </a:t>
                      </a:r>
                      <a:r>
                        <a:rPr lang="en-GB" sz="1000">
                          <a:effectLst/>
                        </a:rPr>
                        <a:t>of peanut butter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1310788146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bout a handful of hazelnuts 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539492281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bout a handful of cashews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2511851768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bout a handful of walnuts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2455873438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bout a handful of pecan nuts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3202078074"/>
                  </a:ext>
                </a:extLst>
              </a:tr>
              <a:tr h="19413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bout a handful of almond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3167407068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bout a handful of pistachio 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1174993287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bout a tblsp of flaxseed/linseed meal 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384186366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User specified open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3380788703"/>
                  </a:ext>
                </a:extLst>
              </a:tr>
              <a:tr h="19413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9)  Do you drink alcoholic beverages?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Never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Monthly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Weekly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Daily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&gt;1/day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1308307421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glass of red wine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2493537902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glass of white wine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513315497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small glass of sherry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1952082168"/>
                  </a:ext>
                </a:extLst>
              </a:tr>
              <a:tr h="2036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glass of rose´ wine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effectLst/>
                        </a:rPr>
                        <a:t> </a:t>
                      </a:r>
                      <a:endParaRPr lang="it-IT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096" marR="47096" marT="0" marB="0"/>
                </a:tc>
                <a:extLst>
                  <a:ext uri="{0D108BD9-81ED-4DB2-BD59-A6C34878D82A}">
                    <a16:rowId xmlns:a16="http://schemas.microsoft.com/office/drawing/2014/main" val="388897107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905013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a 3">
            <a:extLst>
              <a:ext uri="{FF2B5EF4-FFF2-40B4-BE49-F238E27FC236}">
                <a16:creationId xmlns:a16="http://schemas.microsoft.com/office/drawing/2014/main" id="{7C3F292B-1DD8-CF3E-61B4-4C4113A5ADB7}"/>
              </a:ext>
            </a:extLst>
          </p:cNvPr>
          <p:cNvGraphicFramePr>
            <a:graphicFrameLocks noGrp="1"/>
          </p:cNvGraphicFramePr>
          <p:nvPr/>
        </p:nvGraphicFramePr>
        <p:xfrm>
          <a:off x="0" y="0"/>
          <a:ext cx="6858000" cy="7727329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4199649">
                  <a:extLst>
                    <a:ext uri="{9D8B030D-6E8A-4147-A177-3AD203B41FA5}">
                      <a16:colId xmlns:a16="http://schemas.microsoft.com/office/drawing/2014/main" val="2820550510"/>
                    </a:ext>
                  </a:extLst>
                </a:gridCol>
                <a:gridCol w="478826">
                  <a:extLst>
                    <a:ext uri="{9D8B030D-6E8A-4147-A177-3AD203B41FA5}">
                      <a16:colId xmlns:a16="http://schemas.microsoft.com/office/drawing/2014/main" val="198880418"/>
                    </a:ext>
                  </a:extLst>
                </a:gridCol>
                <a:gridCol w="615279">
                  <a:extLst>
                    <a:ext uri="{9D8B030D-6E8A-4147-A177-3AD203B41FA5}">
                      <a16:colId xmlns:a16="http://schemas.microsoft.com/office/drawing/2014/main" val="2125880364"/>
                    </a:ext>
                  </a:extLst>
                </a:gridCol>
                <a:gridCol w="561938">
                  <a:extLst>
                    <a:ext uri="{9D8B030D-6E8A-4147-A177-3AD203B41FA5}">
                      <a16:colId xmlns:a16="http://schemas.microsoft.com/office/drawing/2014/main" val="2667497594"/>
                    </a:ext>
                  </a:extLst>
                </a:gridCol>
                <a:gridCol w="439130">
                  <a:extLst>
                    <a:ext uri="{9D8B030D-6E8A-4147-A177-3AD203B41FA5}">
                      <a16:colId xmlns:a16="http://schemas.microsoft.com/office/drawing/2014/main" val="887058499"/>
                    </a:ext>
                  </a:extLst>
                </a:gridCol>
                <a:gridCol w="563178">
                  <a:extLst>
                    <a:ext uri="{9D8B030D-6E8A-4147-A177-3AD203B41FA5}">
                      <a16:colId xmlns:a16="http://schemas.microsoft.com/office/drawing/2014/main" val="2471629446"/>
                    </a:ext>
                  </a:extLst>
                </a:gridCol>
              </a:tblGrid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pint of dark beer such as Guinness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2624932640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pint of ale beer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1522395573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pint of regular beer such as Larger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2095236278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glass of alcoholic cider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788780356"/>
                  </a:ext>
                </a:extLst>
              </a:tr>
              <a:tr h="17556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shot of spirit – if yes type: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3975190289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User specified open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it-IT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1305623820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10) Do you eat beans or vegetables? 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Never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Monthly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Weekly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Daily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&gt;1/day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1693835858"/>
                  </a:ext>
                </a:extLst>
              </a:tr>
              <a:tr h="1744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medium serve of spinach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2425067965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medium serve of red onion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3858449429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medium serve of regular onion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937653944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medium serve of shallots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483047102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medium potato or serve chips or mash (spuds)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1578795018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medium serve of broccoli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2909859190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medium serve of cauliflower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689255326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medium serve of pumpkin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3737132175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medium serve of carrots 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1196230180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medium serve of green beans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3545946724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medium serve of asparagus (5 spears)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3109095611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few slices of avocado 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1309121413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medium serve of tomato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2004565337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medium side of green lettuce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987133516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medium serve of green bell pepper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260081696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medium serve of black bean 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4046100732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medium serve of white bean (navy/ haricot) such as baked beans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2931312023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medium serve of broad beans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1947659469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medium serve of kidney beans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2908199267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User specified open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1074665917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11) Miscellaneous  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Never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Monthly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Weekly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Daily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&gt;1/day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296838210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One tub or bowl of soy yoghurt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199778955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glass of soy milk 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4103321013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¼ cup of tofu 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2139295864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handful of black olives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680947309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handful of green olives 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2562148401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few dried prunes 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481718593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A box of raisins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2916250737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One </a:t>
                      </a:r>
                      <a:r>
                        <a:rPr lang="it-IT" sz="1000">
                          <a:effectLst/>
                        </a:rPr>
                        <a:t>tblsp </a:t>
                      </a:r>
                      <a:r>
                        <a:rPr lang="en-GB" sz="1000">
                          <a:effectLst/>
                        </a:rPr>
                        <a:t>of extra virgin olive oil 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4290933753"/>
                  </a:ext>
                </a:extLst>
              </a:tr>
              <a:tr h="17758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One tblsp of rapeseed oil 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87761846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One tblsp lemon juice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2998326442"/>
                  </a:ext>
                </a:extLst>
              </a:tr>
              <a:tr h="1951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Supplements – if yes type/dose: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2395015540"/>
                  </a:ext>
                </a:extLst>
              </a:tr>
              <a:tr h="1744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User specified open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it-IT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effectLst/>
                        </a:rPr>
                        <a:t> </a:t>
                      </a:r>
                      <a:endParaRPr lang="it-IT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139" marR="57139" marT="0" marB="0"/>
                </a:tc>
                <a:extLst>
                  <a:ext uri="{0D108BD9-81ED-4DB2-BD59-A6C34878D82A}">
                    <a16:rowId xmlns:a16="http://schemas.microsoft.com/office/drawing/2014/main" val="194192608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9764972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666</Words>
  <Application>Microsoft Macintosh PowerPoint</Application>
  <PresentationFormat>A4 (21x29,7 cm)</PresentationFormat>
  <Paragraphs>706</Paragraphs>
  <Slides>4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Donato ANGELINO</dc:creator>
  <cp:lastModifiedBy>Donato ANGELINO</cp:lastModifiedBy>
  <cp:revision>5</cp:revision>
  <dcterms:created xsi:type="dcterms:W3CDTF">2022-06-27T12:20:20Z</dcterms:created>
  <dcterms:modified xsi:type="dcterms:W3CDTF">2023-04-18T14:51:20Z</dcterms:modified>
</cp:coreProperties>
</file>